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044" y="-3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ED2289-3EE5-CED5-A7D6-FEDB5902DC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2F69BF-7232-F8F3-359B-AAF6CC94F5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81FCD9-E8EA-6B0C-DB19-ACE4DB7A2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3717B8-6388-5223-8FC9-6956C425C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C39A1F-DEE9-C847-5500-9A48AEBD3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344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41FA79-B104-41B7-6955-33E0FC5C12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97C421-F2FF-38B1-7F0A-A41C618D28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D6ACDF-B541-5E2D-4743-EFC8FFECA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4D686E-396A-E24C-84E4-AB56AA04C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B10208-EE69-E0D0-74D8-08BE93DFC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684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E822E3-C755-ACC7-5956-60457D5459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8EDC37-5D63-A13A-F11C-C5CAC02AC1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082771-3641-B8C5-6AB5-C511E14F9A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9A6C2A-D913-7186-56A8-385464E6E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8C4AAB-6DE1-4690-66E1-3C256046D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114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4E393-2473-DA2A-73D5-2FD3F919AC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26D910-9A99-DE70-903C-8441A45CE7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FDA39C-700E-D442-1E58-EE1C9876E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C3B1B0-77C6-0B0A-6FBA-18794530F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2785A8-E0C3-46D3-B5DA-E61E8C05C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629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92BD79-E8DF-34E5-2C38-276FCB8922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2478BE-B7B1-2A65-3C70-89F1424BB8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2BC78-9526-AEB1-4D03-3687E4330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31B374-3CDD-07D0-78C9-37ECB9C1B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2953F1-8502-E5FB-29D8-28F593179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806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B69855-5E48-B960-658A-F2DEF9F687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0CBCBD-774D-5EDC-6C7C-68F4EE6D6D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E9E243-916E-6943-0507-545966A439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1DFDF3-4A0A-4512-FE6B-BB53B602B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CF34A3-BFFF-1221-D32C-EC674574C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0C12E6-D0DE-8596-A029-FB6D8CDBF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944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3EEA04-CD9C-C921-9138-091A4F8B97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EE760B-9468-C393-AC8B-A8FC262B85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47A43A-3E7C-DEB0-E00F-4F160B799F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8ED0DC-34F3-3F5B-0EF8-2FA31BD391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4AFA53-A7DC-7F04-C897-F109C69417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5E5308-DCF5-D520-6BD9-FC7D943D5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4EA6FC-98F8-5B80-B784-0F89EB33D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08848D-DBAD-F927-CA6A-6E01554F6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712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3C6AF3-2762-A004-081C-202C564FDF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F7B844-0B59-26B5-311A-9A2F33F0F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93755C-05D5-E0A5-2517-3BD6A7E3A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4B525F-A5D2-F595-1388-A0CAA137D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941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592E21-FDEF-13F8-6DDD-326D30AE1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A9F317-0C7D-94DB-876C-4DB408CF8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2EE1C8-F568-B487-F987-D443031A4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999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45AC0-2747-B4B4-CA80-612CB42DE4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B67882-28CF-9794-D8DE-8089D80CDE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598126-9CAB-EB96-E960-D70C04915C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CD742F-4291-DBB2-CD3D-097FF1E59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71DA95-3CB5-C18F-5A6F-0850C8018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667F31-8B6E-A309-DDE6-BC8EC996C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574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DCCC5F-5BB3-25E3-AD96-9FBF41B082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18B340-044C-AB45-2784-129B8A556B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35AD3A-537F-4C28-B2EC-1C0B6316E5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893641-5F9D-B67E-8E9B-B700D94A0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9730CD-5587-E470-912F-769A0A9BB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115F62-AE19-FE5F-6EF5-9F9C96817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655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AB155F-20B6-41D8-41BD-AE6D06D43C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56A6C3-E088-5E31-BDEB-B0E13BC485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5171C7-9B64-D380-E13A-9FE9C9C4BF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13BDA0-9264-4311-AAFA-F204ECFE9EB7}" type="datetimeFigureOut">
              <a:rPr lang="en-US" smtClean="0"/>
              <a:t>11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665C2A-34BC-04A6-0EB3-9921E5648E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1ED49E-FF54-6F74-3ACA-6599215947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5E0B0B-D725-4DB4-B5F8-23B5479B66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737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08471E31-DA45-A860-D597-FED46C7BD112}"/>
              </a:ext>
            </a:extLst>
          </p:cNvPr>
          <p:cNvSpPr txBox="1"/>
          <p:nvPr/>
        </p:nvSpPr>
        <p:spPr>
          <a:xfrm>
            <a:off x="0" y="-20919"/>
            <a:ext cx="2428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D22C217-9D06-937E-54AD-F445DE4DE42F}"/>
              </a:ext>
            </a:extLst>
          </p:cNvPr>
          <p:cNvSpPr txBox="1"/>
          <p:nvPr/>
        </p:nvSpPr>
        <p:spPr>
          <a:xfrm>
            <a:off x="110899" y="3710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30777F6-6A61-5C27-34B1-251CB9A791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570" y="148358"/>
            <a:ext cx="6321995" cy="403250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2045A2F-1BCE-357D-DA82-0EEA40F408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7325" y="4234228"/>
            <a:ext cx="6280484" cy="4033143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7492C772-CE12-EAAE-819A-A8B7BE14DFFD}"/>
              </a:ext>
            </a:extLst>
          </p:cNvPr>
          <p:cNvSpPr txBox="1"/>
          <p:nvPr/>
        </p:nvSpPr>
        <p:spPr>
          <a:xfrm>
            <a:off x="131654" y="475879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F477CA7-1042-EB8E-13B8-3F83CC3BACF0}"/>
              </a:ext>
            </a:extLst>
          </p:cNvPr>
          <p:cNvSpPr txBox="1"/>
          <p:nvPr/>
        </p:nvSpPr>
        <p:spPr>
          <a:xfrm>
            <a:off x="29093" y="8432733"/>
            <a:ext cx="67915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The gating strategy used for flow cytometric analysis in THP-1 cells is shown. Initially, a forward scatter (FSC) area versus FSC height plot was used to isolate single cells, thereby excluding doublets and cell aggregates. This "Singlets" gate, ensuring that only single-cell events were included in subsequent analysis. Next, a side scatter (SSC) versus FSC plot was applied to the singlet population to identify the THP-1 macrophage population based on cell size and granularity. Cells within this gate, labeled "THP-1 Cells," represented 92-98% of the singlet population, providing a highly purified subset of THP-1 macrophages for further examination. (A) To identify the pro-inflammatory profile, THP-1 cells were gated on a CD11b versus HLA-DR plot, selecting for CD11b+HLA-DR+ subsets. (B) For the isolation and identification of IRF5+ subsets, cells were gated on a CD11b versus IRF5 plot to identify the CD11b+IRF5+ population. This sequential gating approach ensures precise selection of specific cell subsets for downstream analysis.</a:t>
            </a:r>
          </a:p>
        </p:txBody>
      </p:sp>
    </p:spTree>
    <p:extLst>
      <p:ext uri="{BB962C8B-B14F-4D97-AF65-F5344CB8AC3E}">
        <p14:creationId xmlns:p14="http://schemas.microsoft.com/office/powerpoint/2010/main" val="4193162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00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r. Fatema Alrashed</dc:creator>
  <cp:lastModifiedBy>Dr. Fatema Alrashed</cp:lastModifiedBy>
  <cp:revision>2</cp:revision>
  <dcterms:created xsi:type="dcterms:W3CDTF">2024-11-13T15:59:53Z</dcterms:created>
  <dcterms:modified xsi:type="dcterms:W3CDTF">2024-11-13T16:19:17Z</dcterms:modified>
</cp:coreProperties>
</file>